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27E52B-A424-4AD5-9544-442F989538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752B8F-9F31-4BFC-87E5-A1F0275CB9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0469C2-7E2D-46CA-8A46-B6A05A5DD8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DFBD0-2DB6-4715-AC7D-0ACD8B8157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31E1F-4747-42FD-80D9-197E84DDD5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625340-8C50-4655-BB99-FEDD919BD9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4D4E3-398B-4A95-B9BB-F0FF6F7C39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8BE5C-AEDC-4AD3-B192-D7FF36F25E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0B831-A833-4078-8BF8-DA11C96B57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91B37E-E0B3-4419-B7CB-383EAB300A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35B7D-0DD1-43EA-82FF-E8592CDD68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FDDAC-43D8-4074-9F7E-15A1A5434B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E6AF7E-231E-4D3C-8B3E-F424882D086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2280" y="1066680"/>
          <a:ext cx="8834400" cy="3657600"/>
        </p:xfrm>
        <a:graphic>
          <a:graphicData uri="http://schemas.openxmlformats.org/drawingml/2006/table">
            <a:tbl>
              <a:tblPr/>
              <a:tblGrid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</a:tblGrid>
              <a:tr h="2048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CA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PAF-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P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CL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ID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L-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A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IC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CEBER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S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Not don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Not don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CA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PAF-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P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887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CL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Not don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ID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L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A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20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IC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CEBER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39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22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bind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S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533520" y="5562720"/>
            <a:ext cx="228600" cy="152280"/>
          </a:xfrm>
          <a:prstGeom prst="rect">
            <a:avLst/>
          </a:prstGeom>
          <a:solidFill>
            <a:srgbClr val="ffa89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33520" y="6019920"/>
            <a:ext cx="228600" cy="1522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986040" y="5973840"/>
            <a:ext cx="162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 binding observ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981720" y="5486400"/>
            <a:ext cx="268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inding observed by pull down 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24T16:46:53Z</dcterms:created>
  <dc:creator>Houston</dc:creator>
  <dc:description/>
  <dc:language>en-US</dc:language>
  <cp:lastModifiedBy>F PIO</cp:lastModifiedBy>
  <dcterms:modified xsi:type="dcterms:W3CDTF">2005-05-16T20:35:45Z</dcterms:modified>
  <cp:revision>20</cp:revision>
  <dc:subject/>
  <dc:title>Slide 1</dc:title>
</cp:coreProperties>
</file>